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  <p:sldId id="267" r:id="rId16"/>
    <p:sldId id="268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16" autoAdjust="0"/>
    <p:restoredTop sz="94660"/>
  </p:normalViewPr>
  <p:slideViewPr>
    <p:cSldViewPr snapToGrid="0">
      <p:cViewPr varScale="1">
        <p:scale>
          <a:sx n="64" d="100"/>
          <a:sy n="64" d="100"/>
        </p:scale>
        <p:origin x="78" y="3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presProps" Target="presProps.xml"/><Relationship Id="rId3" Type="http://schemas.openxmlformats.org/officeDocument/2006/relationships/customXml" Target="../customXml/item3.xml"/><Relationship Id="rId21" Type="http://schemas.openxmlformats.org/officeDocument/2006/relationships/tableStyles" Target="tableStyle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27FA6A-5AE8-4E38-A346-26A1536C1E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C086FBF-932F-4624-A07F-B94AB51B8C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954291C-5441-4EE9-8E8D-7B7F519C61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59288-7613-4EE5-9066-1B4091777462}" type="datetimeFigureOut">
              <a:rPr lang="en-US" smtClean="0"/>
              <a:t>11/1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47F05CD-35D3-4F35-BC87-F1D36A596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7540F3-ADDA-4A5E-B9EC-35C3EA38E6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7322-F03F-4DF3-B983-13B673D61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732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2BAA259-BA69-442F-A1E7-6F05A1C152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3461074-9641-46DD-8CA6-872A4477D8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EF51F6A-C6FA-4245-8DF4-082367BF3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59288-7613-4EE5-9066-1B4091777462}" type="datetimeFigureOut">
              <a:rPr lang="en-US" smtClean="0"/>
              <a:t>11/1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148364C-7747-48CD-BFAA-78128CF70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85EB987-BB0D-4795-9E02-7DF934BE4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7322-F03F-4DF3-B983-13B673D61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235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3E3C258-CFCB-42D6-95CC-885F161220E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698FB2B-E139-4082-9FDE-8A7DA51EB2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5DA8450-F2F7-4D56-8B58-C5BFC00774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59288-7613-4EE5-9066-1B4091777462}" type="datetimeFigureOut">
              <a:rPr lang="en-US" smtClean="0"/>
              <a:t>11/1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45AC2B-CAC1-4782-9C86-0E4ADD0FCD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964BA0-D4C1-4036-8A10-B60DE88AF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7322-F03F-4DF3-B983-13B673D61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8583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DDD119-3288-4EEA-A953-6B6F25DD09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109F8DA-0C02-418E-A1CE-2DF771D1CB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33D84AD-942C-4E9A-823B-43220FEB5E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59288-7613-4EE5-9066-1B4091777462}" type="datetimeFigureOut">
              <a:rPr lang="en-US" smtClean="0"/>
              <a:t>11/1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AE06B5-CBAE-482A-8294-3AAC771BE7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0D2AB07-01BF-417D-AEDE-FBA470B88E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7322-F03F-4DF3-B983-13B673D61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910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D87F87-DE1D-4B26-BCE2-58F0DA1B0D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B609036-D7A8-4C48-B0B1-3799258D7E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4968731-BFF3-4ACA-8A01-BC6DE566C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59288-7613-4EE5-9066-1B4091777462}" type="datetimeFigureOut">
              <a:rPr lang="en-US" smtClean="0"/>
              <a:t>11/1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9AFA74-6F55-4A00-B5F3-94160092B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6B1EDD6-8E7A-48C6-8F3E-5CC04D85E4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7322-F03F-4DF3-B983-13B673D61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5513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1C243D-400E-4EB2-9EEA-D6297F0B8A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B7B37C5-4AA1-473A-8612-F8219B9718C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1419308-1116-4B94-864A-D219EA721A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69F294E-FE15-4328-A00C-B72717E3A2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59288-7613-4EE5-9066-1B4091777462}" type="datetimeFigureOut">
              <a:rPr lang="en-US" smtClean="0"/>
              <a:t>11/1/2024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F955D07-EBA1-4726-83F7-846CF4152C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0C2BDD4-62E5-4B57-AB3F-DAB5523FCC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7322-F03F-4DF3-B983-13B673D61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596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2435EC-5BA6-4F63-8372-8710A3DCFB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A9BC10D-8F34-4E63-A2D4-8E0C330157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F7D14EE-A05E-4089-B8EC-D61C36A07D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7BD5FB0-D542-4BEB-B312-3C3D6817A8E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6C9CDA5-953D-4976-842A-D59F006F05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86AE908-8DF3-448C-87FF-36132A3C56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59288-7613-4EE5-9066-1B4091777462}" type="datetimeFigureOut">
              <a:rPr lang="en-US" smtClean="0"/>
              <a:t>11/1/2024</a:t>
            </a:fld>
            <a:endParaRPr 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B0AB2B4-F094-4900-A015-EFB071CFBD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3ECFB49-F28D-4ED2-8186-38550BA88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7322-F03F-4DF3-B983-13B673D61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24895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E3CA820-970A-43F5-8765-D1C9299669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513B2E4-7ED2-4FD7-8AD9-03FD06317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59288-7613-4EE5-9066-1B4091777462}" type="datetimeFigureOut">
              <a:rPr lang="en-US" smtClean="0"/>
              <a:t>11/1/2024</a:t>
            </a:fld>
            <a:endParaRPr 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D98C9FD-EFB4-47D6-A2AE-C28E376E61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BE6AAD4-D7ED-4569-B07F-FD3748F0AE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7322-F03F-4DF3-B983-13B673D61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847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5D55367-3248-4C68-920C-A2D8CB1FD6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59288-7613-4EE5-9066-1B4091777462}" type="datetimeFigureOut">
              <a:rPr lang="en-US" smtClean="0"/>
              <a:t>11/1/2024</a:t>
            </a:fld>
            <a:endParaRPr 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F5A8271-538B-4398-BC5A-196AEC69CF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182A2A8-E7BA-4A6D-A8FA-2380EC6A52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7322-F03F-4DF3-B983-13B673D61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799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D82FDC-6A80-4D6B-A4B9-20E181C876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2FADB99-02C9-42D1-A846-AA4CABDA642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7505A1D-431E-46DF-B3F9-0362BDD887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1DCD91B-7967-42A8-8AD6-0098AC62C4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59288-7613-4EE5-9066-1B4091777462}" type="datetimeFigureOut">
              <a:rPr lang="en-US" smtClean="0"/>
              <a:t>11/1/2024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9F8379B-5D88-4DEB-9A7E-C220D6E87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D6BE2B6-E40D-42C6-A0C3-FD208693AC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7322-F03F-4DF3-B983-13B673D61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051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E6D1FD-4DDE-464B-9600-E8DA817634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A02B492-4977-4E75-963C-240BEFEF66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5158E57-AB4F-46CB-8012-F1FAC8F868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41B2D86-0AAB-4F5F-A0E5-F5F3198B72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59288-7613-4EE5-9066-1B4091777462}" type="datetimeFigureOut">
              <a:rPr lang="en-US" smtClean="0"/>
              <a:t>11/1/2024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635F89E-A33E-409D-B365-698A53A0E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D031283-BD75-40B3-95FF-B34E3529D9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D7322-F03F-4DF3-B983-13B673D61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8555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A32B1AB-FC32-4AB0-A051-714CB86010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742DF08-87C8-49D9-9965-2A91313087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DB9C48C-C892-4D1F-AC0F-2FEE3C2561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059288-7613-4EE5-9066-1B4091777462}" type="datetimeFigureOut">
              <a:rPr lang="en-US" smtClean="0"/>
              <a:t>11/1/2024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127504E-317F-49F4-BE1F-927CDB9CEF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996BC82-66B2-4485-BF49-A3AFB22214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BD7322-F03F-4DF3-B983-13B673D61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637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17172BA-2453-47A8-AF8E-2C6263B72A66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CG2</a:t>
            </a:r>
            <a:endParaRPr lang="zh-CN" altLang="en-US" sz="2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1C0D7F09-2EF6-46BB-9801-F7B540FE1C9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761740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700889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17172BA-2453-47A8-AF8E-2C6263B72A66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LXIPL</a:t>
            </a:r>
            <a:endParaRPr lang="zh-CN" altLang="en-US" sz="2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41AD1D9-2775-4D55-B7F4-8C29BA9166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761740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975586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17172BA-2453-47A8-AF8E-2C6263B72A66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REB1 </a:t>
            </a:r>
            <a:endParaRPr lang="zh-CN" altLang="en-US" sz="2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EE4E8F4-0384-4589-9D7C-956E6076D68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761740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494173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17172BA-2453-47A8-AF8E-2C6263B72A66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OL1</a:t>
            </a:r>
            <a:endParaRPr lang="zh-CN" altLang="en-US" sz="2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296AEE1-B458-4445-9E01-3661D400FE3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761740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610371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17172BA-2453-47A8-AF8E-2C6263B72A66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LC16A9</a:t>
            </a:r>
            <a:endParaRPr lang="zh-CN" altLang="en-US" sz="2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43A66C8D-30B4-4373-9C7D-835912B541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184" y="1304540"/>
            <a:ext cx="11687632" cy="37918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92689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17172BA-2453-47A8-AF8E-2C6263B72A66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LC2A9</a:t>
            </a:r>
            <a:endParaRPr lang="zh-CN" altLang="en-US" sz="2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0C119B4-563C-44D6-AAE4-4F8A1E5379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51" y="1714588"/>
            <a:ext cx="12047897" cy="34288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0959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17172BA-2453-47A8-AF8E-2C6263B72A66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LC17A1</a:t>
            </a:r>
            <a:endParaRPr lang="zh-CN" altLang="en-US" sz="2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C86D398-BE24-41E5-9373-545592960A7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761740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69563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17172BA-2453-47A8-AF8E-2C6263B72A66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CKR</a:t>
            </a:r>
            <a:endParaRPr lang="zh-CN" altLang="en-US" sz="2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709983C-C550-400F-88CA-8E7B1406057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761740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23221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17172BA-2453-47A8-AF8E-2C6263B72A66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LC22A11</a:t>
            </a:r>
            <a:endParaRPr lang="zh-CN" altLang="en-US" sz="2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809361B-1E60-44E8-B897-2DE51788252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905" y="980175"/>
            <a:ext cx="10956188" cy="42383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62403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17172BA-2453-47A8-AF8E-2C6263B72A66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H1B</a:t>
            </a:r>
            <a:endParaRPr lang="zh-CN" altLang="en-US" sz="2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605348D-E79A-4604-B25A-935913038B1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761740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92276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17172BA-2453-47A8-AF8E-2C6263B72A66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60</a:t>
            </a:r>
            <a:endParaRPr lang="zh-CN" altLang="en-US" sz="2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B1F8E31-4E73-44C2-B50D-2EBCA803A9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622" y="980175"/>
            <a:ext cx="11312755" cy="41953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58887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17172BA-2453-47A8-AF8E-2C6263B72A66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BE2Q2</a:t>
            </a:r>
            <a:endParaRPr lang="zh-CN" altLang="en-US" sz="2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C2915F5B-8F8B-47F0-B97E-4681FEA7EC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545" y="1129728"/>
            <a:ext cx="11668909" cy="40093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260478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17172BA-2453-47A8-AF8E-2C6263B72A66}"/>
              </a:ext>
            </a:extLst>
          </p:cNvPr>
          <p:cNvSpPr txBox="1"/>
          <p:nvPr/>
        </p:nvSpPr>
        <p:spPr>
          <a:xfrm>
            <a:off x="4368434" y="5446938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3</a:t>
            </a:r>
            <a:endParaRPr lang="zh-CN" altLang="en-US" sz="2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7542CBD-E892-4578-B6A1-9C9CA1B284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761740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81829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文档" ma:contentTypeID="0x0101002618253C799C944CABB8769CC3A2E194" ma:contentTypeVersion="13" ma:contentTypeDescription="新建文档。" ma:contentTypeScope="" ma:versionID="880e21d1dd010b9b11028ac75e0fb754">
  <xsd:schema xmlns:xsd="http://www.w3.org/2001/XMLSchema" xmlns:xs="http://www.w3.org/2001/XMLSchema" xmlns:p="http://schemas.microsoft.com/office/2006/metadata/properties" xmlns:ns3="32af06ad-3f78-449f-a736-998b0ae618d0" xmlns:ns4="e8428ea2-6cbc-44cf-8036-3d22bfb5543c" targetNamespace="http://schemas.microsoft.com/office/2006/metadata/properties" ma:root="true" ma:fieldsID="585dc5a3f0d0a8dd7f82b0495baaed98" ns3:_="" ns4:_="">
    <xsd:import namespace="32af06ad-3f78-449f-a736-998b0ae618d0"/>
    <xsd:import namespace="e8428ea2-6cbc-44cf-8036-3d22bfb5543c"/>
    <xsd:element name="properties">
      <xsd:complexType>
        <xsd:sequence>
          <xsd:element name="documentManagement">
            <xsd:complexType>
              <xsd:all>
                <xsd:element ref="ns3:_activity" minOccurs="0"/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  <xsd:element ref="ns3:MediaServiceSearchProperties" minOccurs="0"/>
                <xsd:element ref="ns3:MediaServiceSystem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2af06ad-3f78-449f-a736-998b0ae618d0" elementFormDefault="qualified">
    <xsd:import namespace="http://schemas.microsoft.com/office/2006/documentManagement/types"/>
    <xsd:import namespace="http://schemas.microsoft.com/office/infopath/2007/PartnerControls"/>
    <xsd:element name="_activity" ma:index="8" nillable="true" ma:displayName="_activity" ma:hidden="true" ma:internalName="_activity">
      <xsd:simpleType>
        <xsd:restriction base="dms:Note"/>
      </xsd:simpleType>
    </xsd:element>
    <xsd:element name="MediaServiceMetadata" ma:index="9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0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SearchProperties" ma:index="16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SystemTags" ma:index="17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8428ea2-6cbc-44cf-8036-3d22bfb5543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共享对象: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共享对象详细信息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共享提示哈希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内容类型"/>
        <xsd:element ref="dc:title" minOccurs="0" maxOccurs="1" ma:index="4" ma:displayName="标题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32af06ad-3f78-449f-a736-998b0ae618d0" xsi:nil="true"/>
  </documentManagement>
</p:properties>
</file>

<file path=customXml/itemProps1.xml><?xml version="1.0" encoding="utf-8"?>
<ds:datastoreItem xmlns:ds="http://schemas.openxmlformats.org/officeDocument/2006/customXml" ds:itemID="{4520C006-9750-41AD-8FFA-42D2E52036B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2af06ad-3f78-449f-a736-998b0ae618d0"/>
    <ds:schemaRef ds:uri="e8428ea2-6cbc-44cf-8036-3d22bfb5543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23C21F0-0A9D-4C74-AE76-89EF91B7EB61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2D83FF94-6E6F-4A49-BA94-11696F9449BA}">
  <ds:schemaRefs>
    <ds:schemaRef ds:uri="http://schemas.microsoft.com/office/2006/documentManagement/types"/>
    <ds:schemaRef ds:uri="32af06ad-3f78-449f-a736-998b0ae618d0"/>
    <ds:schemaRef ds:uri="http://purl.org/dc/terms/"/>
    <ds:schemaRef ds:uri="http://purl.org/dc/elements/1.1/"/>
    <ds:schemaRef ds:uri="http://www.w3.org/XML/1998/namespace"/>
    <ds:schemaRef ds:uri="http://schemas.microsoft.com/office/infopath/2007/PartnerControls"/>
    <ds:schemaRef ds:uri="e8428ea2-6cbc-44cf-8036-3d22bfb5543c"/>
    <ds:schemaRef ds:uri="http://schemas.openxmlformats.org/package/2006/metadata/core-properties"/>
    <ds:schemaRef ds:uri="http://schemas.microsoft.com/office/2006/metadata/properties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39</Words>
  <Application>Microsoft Office PowerPoint</Application>
  <PresentationFormat>宽屏</PresentationFormat>
  <Paragraphs>13</Paragraphs>
  <Slides>1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3</vt:i4>
      </vt:variant>
    </vt:vector>
  </HeadingPairs>
  <TitlesOfParts>
    <vt:vector size="19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wen TAO (20617230)</dc:creator>
  <cp:lastModifiedBy>Yiwen TAO (20617230)</cp:lastModifiedBy>
  <cp:revision>5</cp:revision>
  <dcterms:created xsi:type="dcterms:W3CDTF">2024-10-30T08:24:12Z</dcterms:created>
  <dcterms:modified xsi:type="dcterms:W3CDTF">2024-11-01T06:30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618253C799C944CABB8769CC3A2E194</vt:lpwstr>
  </property>
</Properties>
</file>